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61163" cy="99425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075E50-DA92-495E-9DDE-28F39FBF15A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4712BB-456A-4BD8-A8D3-DCEA81C32F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638D54-B4F9-42C9-BF8B-0B8E7B4A597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73CEEC-0FF3-4751-87BB-EB037E9627F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FDFDF6-F1DF-4735-BDB6-4737F6D59CF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F6D5AB-C82A-4334-B1DA-1DC7008CBCF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B4AB0D-8F6E-447B-B63C-AB7F6AE1BCC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23C44F-2C98-409A-B4A6-8C2DA3CF51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1F6BED-728B-4AA1-AF6B-0FAE740EFFF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713106-C2F8-4C48-B67B-6D04808254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1BC596-2E53-4E2E-9DD6-6AA0E8B9DF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0D7597-B1D7-4466-A073-9EE31E616B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0C47BED-48AC-4893-88E6-5D198E7DF9D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0" descr=""/>
          <p:cNvPicPr/>
          <p:nvPr/>
        </p:nvPicPr>
        <p:blipFill>
          <a:blip r:embed="rId1"/>
          <a:srcRect l="0" t="0" r="18462" b="7812"/>
          <a:stretch/>
        </p:blipFill>
        <p:spPr>
          <a:xfrm>
            <a:off x="3749760" y="987480"/>
            <a:ext cx="2422440" cy="25686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29" descr=""/>
          <p:cNvPicPr/>
          <p:nvPr/>
        </p:nvPicPr>
        <p:blipFill>
          <a:blip r:embed="rId2"/>
          <a:stretch/>
        </p:blipFill>
        <p:spPr>
          <a:xfrm>
            <a:off x="1495440" y="4081320"/>
            <a:ext cx="3838680" cy="2838600"/>
          </a:xfrm>
          <a:prstGeom prst="rect">
            <a:avLst/>
          </a:prstGeom>
          <a:ln w="0">
            <a:noFill/>
          </a:ln>
        </p:spPr>
      </p:pic>
      <p:sp>
        <p:nvSpPr>
          <p:cNvPr id="43" name="TextBox 98"/>
          <p:cNvSpPr/>
          <p:nvPr/>
        </p:nvSpPr>
        <p:spPr>
          <a:xfrm>
            <a:off x="2392200" y="6672240"/>
            <a:ext cx="623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200" spc="-1" strike="noStrike">
                <a:solidFill>
                  <a:srgbClr val="000000"/>
                </a:solidFill>
                <a:latin typeface="Arial"/>
              </a:rPr>
              <a:t>48 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101"/>
          <p:cNvSpPr/>
          <p:nvPr/>
        </p:nvSpPr>
        <p:spPr>
          <a:xfrm>
            <a:off x="303120" y="744480"/>
            <a:ext cx="304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102"/>
          <p:cNvSpPr/>
          <p:nvPr/>
        </p:nvSpPr>
        <p:spPr>
          <a:xfrm>
            <a:off x="3627360" y="760320"/>
            <a:ext cx="241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103"/>
          <p:cNvSpPr/>
          <p:nvPr/>
        </p:nvSpPr>
        <p:spPr>
          <a:xfrm>
            <a:off x="1295280" y="3929040"/>
            <a:ext cx="304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Straight Connector 105"/>
          <p:cNvSpPr/>
          <p:nvPr/>
        </p:nvSpPr>
        <p:spPr>
          <a:xfrm>
            <a:off x="2133720" y="6721560"/>
            <a:ext cx="1044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106"/>
          <p:cNvSpPr/>
          <p:nvPr/>
        </p:nvSpPr>
        <p:spPr>
          <a:xfrm>
            <a:off x="4122720" y="6676920"/>
            <a:ext cx="525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72 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Straight Connector 107"/>
          <p:cNvSpPr/>
          <p:nvPr/>
        </p:nvSpPr>
        <p:spPr>
          <a:xfrm>
            <a:off x="3755880" y="6718320"/>
            <a:ext cx="1044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122"/>
          <p:cNvSpPr/>
          <p:nvPr/>
        </p:nvSpPr>
        <p:spPr>
          <a:xfrm>
            <a:off x="2209680" y="8043840"/>
            <a:ext cx="2286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uppl. Figure 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71"/>
          <p:cNvSpPr/>
          <p:nvPr/>
        </p:nvSpPr>
        <p:spPr>
          <a:xfrm rot="16200000">
            <a:off x="-583200" y="2035440"/>
            <a:ext cx="21711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Percent cell cycle distribution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72"/>
          <p:cNvSpPr/>
          <p:nvPr/>
        </p:nvSpPr>
        <p:spPr>
          <a:xfrm rot="16200000">
            <a:off x="2599200" y="2057040"/>
            <a:ext cx="21711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Percent cell cycle distribution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73"/>
          <p:cNvSpPr/>
          <p:nvPr/>
        </p:nvSpPr>
        <p:spPr>
          <a:xfrm rot="16200000">
            <a:off x="459360" y="5257440"/>
            <a:ext cx="21711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Percent cell cycle distribution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4" name="Group 25"/>
          <p:cNvGrpSpPr/>
          <p:nvPr/>
        </p:nvGrpSpPr>
        <p:grpSpPr>
          <a:xfrm>
            <a:off x="2438280" y="531720"/>
            <a:ext cx="990720" cy="806760"/>
            <a:chOff x="2438280" y="531720"/>
            <a:chExt cx="990720" cy="806760"/>
          </a:xfrm>
        </p:grpSpPr>
        <p:sp>
          <p:nvSpPr>
            <p:cNvPr id="55" name="Rectangle 35"/>
            <p:cNvSpPr/>
            <p:nvPr/>
          </p:nvSpPr>
          <p:spPr>
            <a:xfrm>
              <a:off x="2438280" y="583920"/>
              <a:ext cx="198360" cy="14904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Rectangle 36"/>
            <p:cNvSpPr/>
            <p:nvPr/>
          </p:nvSpPr>
          <p:spPr>
            <a:xfrm>
              <a:off x="2438280" y="765000"/>
              <a:ext cx="198360" cy="149040"/>
            </a:xfrm>
            <a:prstGeom prst="rect">
              <a:avLst/>
            </a:prstGeom>
            <a:solidFill>
              <a:srgbClr val="bfbfb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Rectangle 37"/>
            <p:cNvSpPr/>
            <p:nvPr/>
          </p:nvSpPr>
          <p:spPr>
            <a:xfrm>
              <a:off x="2438280" y="952560"/>
              <a:ext cx="198360" cy="149040"/>
            </a:xfrm>
            <a:prstGeom prst="rect">
              <a:avLst/>
            </a:prstGeom>
            <a:solidFill>
              <a:srgbClr val="595959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Rectangle 38"/>
            <p:cNvSpPr/>
            <p:nvPr/>
          </p:nvSpPr>
          <p:spPr>
            <a:xfrm>
              <a:off x="2438280" y="1138320"/>
              <a:ext cx="198360" cy="15084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Box 21"/>
            <p:cNvSpPr/>
            <p:nvPr/>
          </p:nvSpPr>
          <p:spPr>
            <a:xfrm>
              <a:off x="2603160" y="531720"/>
              <a:ext cx="825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TextBox 22"/>
            <p:cNvSpPr/>
            <p:nvPr/>
          </p:nvSpPr>
          <p:spPr>
            <a:xfrm>
              <a:off x="2603160" y="718560"/>
              <a:ext cx="825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 </a:t>
              </a:r>
              <a:r>
                <a:rPr b="0" lang="en-U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 S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TextBox 23"/>
            <p:cNvSpPr/>
            <p:nvPr/>
          </p:nvSpPr>
          <p:spPr>
            <a:xfrm>
              <a:off x="2603160" y="905400"/>
              <a:ext cx="825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60 </a:t>
              </a:r>
              <a:r>
                <a:rPr b="0" lang="en-U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 S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TextBox 24"/>
            <p:cNvSpPr/>
            <p:nvPr/>
          </p:nvSpPr>
          <p:spPr>
            <a:xfrm>
              <a:off x="2603160" y="1092240"/>
              <a:ext cx="825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90 </a:t>
              </a:r>
              <a:r>
                <a:rPr b="0" lang="en-U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 S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3" name="Group 25"/>
          <p:cNvGrpSpPr/>
          <p:nvPr/>
        </p:nvGrpSpPr>
        <p:grpSpPr>
          <a:xfrm>
            <a:off x="5791320" y="500040"/>
            <a:ext cx="990360" cy="806760"/>
            <a:chOff x="5791320" y="500040"/>
            <a:chExt cx="990360" cy="806760"/>
          </a:xfrm>
        </p:grpSpPr>
        <p:sp>
          <p:nvSpPr>
            <p:cNvPr id="64" name="Rectangle 46"/>
            <p:cNvSpPr/>
            <p:nvPr/>
          </p:nvSpPr>
          <p:spPr>
            <a:xfrm>
              <a:off x="5791320" y="552240"/>
              <a:ext cx="198360" cy="14904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Rectangle 47"/>
            <p:cNvSpPr/>
            <p:nvPr/>
          </p:nvSpPr>
          <p:spPr>
            <a:xfrm>
              <a:off x="5791320" y="733320"/>
              <a:ext cx="198360" cy="149040"/>
            </a:xfrm>
            <a:prstGeom prst="rect">
              <a:avLst/>
            </a:prstGeom>
            <a:solidFill>
              <a:srgbClr val="bfbfb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Rectangle 48"/>
            <p:cNvSpPr/>
            <p:nvPr/>
          </p:nvSpPr>
          <p:spPr>
            <a:xfrm>
              <a:off x="5791320" y="920880"/>
              <a:ext cx="198360" cy="149040"/>
            </a:xfrm>
            <a:prstGeom prst="rect">
              <a:avLst/>
            </a:prstGeom>
            <a:solidFill>
              <a:srgbClr val="595959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Rectangle 49"/>
            <p:cNvSpPr/>
            <p:nvPr/>
          </p:nvSpPr>
          <p:spPr>
            <a:xfrm>
              <a:off x="5791320" y="1106640"/>
              <a:ext cx="198360" cy="15084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TextBox 21"/>
            <p:cNvSpPr/>
            <p:nvPr/>
          </p:nvSpPr>
          <p:spPr>
            <a:xfrm>
              <a:off x="5956200" y="500040"/>
              <a:ext cx="825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TextBox 22"/>
            <p:cNvSpPr/>
            <p:nvPr/>
          </p:nvSpPr>
          <p:spPr>
            <a:xfrm>
              <a:off x="5956200" y="686880"/>
              <a:ext cx="825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 </a:t>
              </a:r>
              <a:r>
                <a:rPr b="0" lang="en-U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 S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TextBox 23"/>
            <p:cNvSpPr/>
            <p:nvPr/>
          </p:nvSpPr>
          <p:spPr>
            <a:xfrm>
              <a:off x="5956200" y="873720"/>
              <a:ext cx="825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60 </a:t>
              </a:r>
              <a:r>
                <a:rPr b="0" lang="en-U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 S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TextBox 24"/>
            <p:cNvSpPr/>
            <p:nvPr/>
          </p:nvSpPr>
          <p:spPr>
            <a:xfrm>
              <a:off x="5956200" y="1060560"/>
              <a:ext cx="825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90 </a:t>
              </a:r>
              <a:r>
                <a:rPr b="0" lang="en-U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 S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2" name="TextBox 131"/>
          <p:cNvSpPr/>
          <p:nvPr/>
        </p:nvSpPr>
        <p:spPr>
          <a:xfrm>
            <a:off x="1382760" y="909720"/>
            <a:ext cx="51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43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149"/>
          <p:cNvSpPr/>
          <p:nvPr/>
        </p:nvSpPr>
        <p:spPr>
          <a:xfrm>
            <a:off x="4727520" y="907920"/>
            <a:ext cx="51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54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4" name="Group 25"/>
          <p:cNvGrpSpPr/>
          <p:nvPr/>
        </p:nvGrpSpPr>
        <p:grpSpPr>
          <a:xfrm>
            <a:off x="4191120" y="4081320"/>
            <a:ext cx="990360" cy="806760"/>
            <a:chOff x="4191120" y="4081320"/>
            <a:chExt cx="990360" cy="806760"/>
          </a:xfrm>
        </p:grpSpPr>
        <p:sp>
          <p:nvSpPr>
            <p:cNvPr id="75" name="Rectangle 60"/>
            <p:cNvSpPr/>
            <p:nvPr/>
          </p:nvSpPr>
          <p:spPr>
            <a:xfrm>
              <a:off x="4191120" y="4133520"/>
              <a:ext cx="198360" cy="14904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Rectangle 61"/>
            <p:cNvSpPr/>
            <p:nvPr/>
          </p:nvSpPr>
          <p:spPr>
            <a:xfrm>
              <a:off x="4191120" y="4314600"/>
              <a:ext cx="198360" cy="149040"/>
            </a:xfrm>
            <a:prstGeom prst="rect">
              <a:avLst/>
            </a:prstGeom>
            <a:solidFill>
              <a:srgbClr val="bfbfb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Rectangle 62"/>
            <p:cNvSpPr/>
            <p:nvPr/>
          </p:nvSpPr>
          <p:spPr>
            <a:xfrm>
              <a:off x="4191120" y="4502160"/>
              <a:ext cx="198360" cy="149040"/>
            </a:xfrm>
            <a:prstGeom prst="rect">
              <a:avLst/>
            </a:prstGeom>
            <a:solidFill>
              <a:srgbClr val="595959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Rectangle 63"/>
            <p:cNvSpPr/>
            <p:nvPr/>
          </p:nvSpPr>
          <p:spPr>
            <a:xfrm>
              <a:off x="4191120" y="4687920"/>
              <a:ext cx="198360" cy="15084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TextBox 21"/>
            <p:cNvSpPr/>
            <p:nvPr/>
          </p:nvSpPr>
          <p:spPr>
            <a:xfrm>
              <a:off x="4356000" y="4081320"/>
              <a:ext cx="825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ontrol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TextBox 22"/>
            <p:cNvSpPr/>
            <p:nvPr/>
          </p:nvSpPr>
          <p:spPr>
            <a:xfrm>
              <a:off x="4356000" y="4268160"/>
              <a:ext cx="825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0 </a:t>
              </a:r>
              <a:r>
                <a:rPr b="0" lang="en-U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 S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TextBox 23"/>
            <p:cNvSpPr/>
            <p:nvPr/>
          </p:nvSpPr>
          <p:spPr>
            <a:xfrm>
              <a:off x="4356000" y="4455000"/>
              <a:ext cx="825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60 </a:t>
              </a:r>
              <a:r>
                <a:rPr b="0" lang="en-U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 S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TextBox 24"/>
            <p:cNvSpPr/>
            <p:nvPr/>
          </p:nvSpPr>
          <p:spPr>
            <a:xfrm>
              <a:off x="4356000" y="4641840"/>
              <a:ext cx="825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90 </a:t>
              </a:r>
              <a:r>
                <a:rPr b="0" lang="en-U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</a:t>
              </a: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 S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83" name="TextBox 129"/>
          <p:cNvSpPr/>
          <p:nvPr/>
        </p:nvSpPr>
        <p:spPr>
          <a:xfrm>
            <a:off x="2695320" y="4157640"/>
            <a:ext cx="1118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DA-MB-23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Box 98"/>
          <p:cNvSpPr/>
          <p:nvPr/>
        </p:nvSpPr>
        <p:spPr>
          <a:xfrm>
            <a:off x="4373640" y="3419640"/>
            <a:ext cx="623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200" spc="-1" strike="noStrike">
                <a:solidFill>
                  <a:srgbClr val="000000"/>
                </a:solidFill>
                <a:latin typeface="Arial"/>
              </a:rPr>
              <a:t>48 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TextBox 106"/>
          <p:cNvSpPr/>
          <p:nvPr/>
        </p:nvSpPr>
        <p:spPr>
          <a:xfrm>
            <a:off x="5494320" y="3424320"/>
            <a:ext cx="525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72 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6" name="Picture 31" descr="C:\Users\Dhanya\Desktop\Picture5.png"/>
          <p:cNvPicPr/>
          <p:nvPr/>
        </p:nvPicPr>
        <p:blipFill>
          <a:blip r:embed="rId3"/>
          <a:stretch/>
        </p:blipFill>
        <p:spPr>
          <a:xfrm>
            <a:off x="609480" y="1100160"/>
            <a:ext cx="2743200" cy="2362320"/>
          </a:xfrm>
          <a:prstGeom prst="rect">
            <a:avLst/>
          </a:prstGeom>
          <a:ln w="0">
            <a:noFill/>
          </a:ln>
        </p:spPr>
      </p:pic>
      <p:sp>
        <p:nvSpPr>
          <p:cNvPr id="87" name="TextBox 98"/>
          <p:cNvSpPr/>
          <p:nvPr/>
        </p:nvSpPr>
        <p:spPr>
          <a:xfrm>
            <a:off x="1163520" y="3395520"/>
            <a:ext cx="623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N" sz="1200" spc="-1" strike="noStrike">
                <a:solidFill>
                  <a:srgbClr val="000000"/>
                </a:solidFill>
                <a:latin typeface="Arial"/>
              </a:rPr>
              <a:t>48 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TextBox 106"/>
          <p:cNvSpPr/>
          <p:nvPr/>
        </p:nvSpPr>
        <p:spPr>
          <a:xfrm>
            <a:off x="2446200" y="3395520"/>
            <a:ext cx="525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72 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92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05T08:28:25Z</dcterms:created>
  <dc:creator>john9</dc:creator>
  <dc:description/>
  <dc:language>en-US</dc:language>
  <cp:lastModifiedBy>Rana P. Singh</cp:lastModifiedBy>
  <cp:lastPrinted>2012-12-05T13:31:29Z</cp:lastPrinted>
  <dcterms:modified xsi:type="dcterms:W3CDTF">2013-07-18T17:54:00Z</dcterms:modified>
  <cp:revision>792</cp:revision>
  <dc:subject/>
  <dc:title>EFFECT OF β-SITOSTEROL ON A-431 Cell line</dc:title>
</cp:coreProperties>
</file>